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384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sfudal\Documents\articles\2019%20Structure%20AvrLm5-9\2021%2012%20juillet%20test%20patho%20cultivars%20Rlm3%2015%20jpi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sfudal\Documents\articles\2019%20Structure%20AvrLm5-9\2021%2012%20juillet%20test%20patho%20cultivars%20Rlm3%2015%20jpi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sfudal\Documents\articles\2019%20Structure%20AvrLm5-9\2021%2012%20juillet%20test%20patho%20cultivars%20Rlm3%2015%20jpi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sfudal\Documents\articles\2019%20Structure%20AvrLm5-9\2021%2012%20juillet%20test%20patho%20cultivars%20Rlm3%2015%20jpi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sfudal\Documents\articles\2019%20Structure%20AvrLm5-9\2021%2012%20juillet%20test%20patho%20cultivars%20Rlm3%2015%20jpi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Grizzly (</a:t>
            </a:r>
            <a:r>
              <a:rPr lang="en-US" i="1" dirty="0"/>
              <a:t>Rlm3</a:t>
            </a:r>
            <a:r>
              <a:rPr lang="en-US" dirty="0"/>
              <a:t>)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14DPI'!$B$9:$J$9</c:f>
              <c:strCache>
                <c:ptCount val="9"/>
                <c:pt idx="0">
                  <c:v>Nz-T4</c:v>
                </c:pt>
                <c:pt idx="1">
                  <c:v>Nz-T4-Ecp11_1</c:v>
                </c:pt>
                <c:pt idx="2">
                  <c:v>Nz-T4-Ecp11_3</c:v>
                </c:pt>
                <c:pt idx="3">
                  <c:v>Nz-T4-Ecp11_4</c:v>
                </c:pt>
                <c:pt idx="4">
                  <c:v>Nz-T4-Ecp11_6</c:v>
                </c:pt>
                <c:pt idx="5">
                  <c:v>Nz-T4-Ecp11_7</c:v>
                </c:pt>
                <c:pt idx="6">
                  <c:v>19.4.24</c:v>
                </c:pt>
                <c:pt idx="7">
                  <c:v>JN3</c:v>
                </c:pt>
                <c:pt idx="8">
                  <c:v>Nz-T4-AvrLm3_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14DPI'!$B$29:$J$29</c:f>
                <c:numCache>
                  <c:formatCode>General</c:formatCode>
                  <c:ptCount val="9"/>
                  <c:pt idx="0">
                    <c:v>0.75592894601845462</c:v>
                  </c:pt>
                  <c:pt idx="1">
                    <c:v>0.25819888974716115</c:v>
                  </c:pt>
                  <c:pt idx="2">
                    <c:v>0.25819888974716115</c:v>
                  </c:pt>
                  <c:pt idx="3">
                    <c:v>0.20412414523193159</c:v>
                  </c:pt>
                  <c:pt idx="4">
                    <c:v>0.34377582547616431</c:v>
                  </c:pt>
                  <c:pt idx="5">
                    <c:v>0.33709993123162107</c:v>
                  </c:pt>
                  <c:pt idx="6">
                    <c:v>0</c:v>
                  </c:pt>
                  <c:pt idx="7">
                    <c:v>0.26967994498529801</c:v>
                  </c:pt>
                  <c:pt idx="8">
                    <c:v>0.23145502494313785</c:v>
                  </c:pt>
                </c:numCache>
              </c:numRef>
            </c:plus>
            <c:minus>
              <c:numRef>
                <c:f>'14DPI'!$B$29:$J$29</c:f>
                <c:numCache>
                  <c:formatCode>General</c:formatCode>
                  <c:ptCount val="9"/>
                  <c:pt idx="0">
                    <c:v>0.75592894601845462</c:v>
                  </c:pt>
                  <c:pt idx="1">
                    <c:v>0.25819888974716115</c:v>
                  </c:pt>
                  <c:pt idx="2">
                    <c:v>0.25819888974716115</c:v>
                  </c:pt>
                  <c:pt idx="3">
                    <c:v>0.20412414523193159</c:v>
                  </c:pt>
                  <c:pt idx="4">
                    <c:v>0.34377582547616431</c:v>
                  </c:pt>
                  <c:pt idx="5">
                    <c:v>0.33709993123162107</c:v>
                  </c:pt>
                  <c:pt idx="6">
                    <c:v>0</c:v>
                  </c:pt>
                  <c:pt idx="7">
                    <c:v>0.26967994498529801</c:v>
                  </c:pt>
                  <c:pt idx="8">
                    <c:v>0.23145502494313785</c:v>
                  </c:pt>
                </c:numCache>
              </c:numRef>
            </c:minus>
          </c:errBars>
          <c:cat>
            <c:strRef>
              <c:f>'14DPI'!$B$9:$J$9</c:f>
              <c:strCache>
                <c:ptCount val="9"/>
                <c:pt idx="0">
                  <c:v>Nz-T4</c:v>
                </c:pt>
                <c:pt idx="1">
                  <c:v>Nz-T4-Ecp11_1</c:v>
                </c:pt>
                <c:pt idx="2">
                  <c:v>Nz-T4-Ecp11_3</c:v>
                </c:pt>
                <c:pt idx="3">
                  <c:v>Nz-T4-Ecp11_4</c:v>
                </c:pt>
                <c:pt idx="4">
                  <c:v>Nz-T4-Ecp11_6</c:v>
                </c:pt>
                <c:pt idx="5">
                  <c:v>Nz-T4-Ecp11_7</c:v>
                </c:pt>
                <c:pt idx="6">
                  <c:v>19.4.24</c:v>
                </c:pt>
                <c:pt idx="7">
                  <c:v>JN3</c:v>
                </c:pt>
                <c:pt idx="8">
                  <c:v>Nz-T4-AvrLm3_1</c:v>
                </c:pt>
              </c:strCache>
            </c:strRef>
          </c:cat>
          <c:val>
            <c:numRef>
              <c:f>'14DPI'!$B$27:$J$27</c:f>
              <c:numCache>
                <c:formatCode>General</c:formatCode>
                <c:ptCount val="9"/>
                <c:pt idx="0">
                  <c:v>4.4285714285714288</c:v>
                </c:pt>
                <c:pt idx="1">
                  <c:v>1.3333333333333333</c:v>
                </c:pt>
                <c:pt idx="2">
                  <c:v>1.2</c:v>
                </c:pt>
                <c:pt idx="3">
                  <c:v>1.1666666666666667</c:v>
                </c:pt>
                <c:pt idx="4">
                  <c:v>1.4545454545454546</c:v>
                </c:pt>
                <c:pt idx="5">
                  <c:v>1.3636363636363635</c:v>
                </c:pt>
                <c:pt idx="6">
                  <c:v>1</c:v>
                </c:pt>
                <c:pt idx="7">
                  <c:v>4.9090909090909092</c:v>
                </c:pt>
                <c:pt idx="8">
                  <c:v>1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F99-47CE-841D-C2EF012469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9446784"/>
        <c:axId val="99449856"/>
      </c:barChart>
      <c:catAx>
        <c:axId val="994467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99449856"/>
        <c:crosses val="autoZero"/>
        <c:auto val="1"/>
        <c:lblAlgn val="ctr"/>
        <c:lblOffset val="100"/>
        <c:noMultiLvlLbl val="0"/>
      </c:catAx>
      <c:valAx>
        <c:axId val="99449856"/>
        <c:scaling>
          <c:orientation val="minMax"/>
          <c:max val="6"/>
        </c:scaling>
        <c:delete val="0"/>
        <c:axPos val="l"/>
        <c:numFmt formatCode="General" sourceLinked="1"/>
        <c:majorTickMark val="none"/>
        <c:minorTickMark val="none"/>
        <c:tickLblPos val="nextTo"/>
        <c:crossAx val="994467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Columbus (</a:t>
            </a:r>
            <a:r>
              <a:rPr lang="en-US" i="1" dirty="0"/>
              <a:t>Rlm3</a:t>
            </a:r>
            <a:r>
              <a:rPr lang="en-US" dirty="0"/>
              <a:t>, </a:t>
            </a:r>
            <a:r>
              <a:rPr lang="en-US" i="1" dirty="0"/>
              <a:t>Rlm1</a:t>
            </a:r>
            <a:r>
              <a:rPr lang="en-US" dirty="0"/>
              <a:t>)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14DPI'!$B$9:$J$9</c:f>
              <c:strCache>
                <c:ptCount val="9"/>
                <c:pt idx="0">
                  <c:v>Nz-T4</c:v>
                </c:pt>
                <c:pt idx="1">
                  <c:v>Nz-T4-Ecp11_1</c:v>
                </c:pt>
                <c:pt idx="2">
                  <c:v>Nz-T4-Ecp11_3</c:v>
                </c:pt>
                <c:pt idx="3">
                  <c:v>Nz-T4-Ecp11_4</c:v>
                </c:pt>
                <c:pt idx="4">
                  <c:v>Nz-T4-Ecp11_6</c:v>
                </c:pt>
                <c:pt idx="5">
                  <c:v>Nz-T4-Ecp11_7</c:v>
                </c:pt>
                <c:pt idx="6">
                  <c:v>19.4.24</c:v>
                </c:pt>
                <c:pt idx="7">
                  <c:v>JN3</c:v>
                </c:pt>
                <c:pt idx="8">
                  <c:v>Nz-T4-AvrLm3_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14DPI'!$R$29:$Z$29</c:f>
                <c:numCache>
                  <c:formatCode>General</c:formatCode>
                  <c:ptCount val="9"/>
                  <c:pt idx="0">
                    <c:v>0.3779644730092272</c:v>
                  </c:pt>
                  <c:pt idx="1">
                    <c:v>0.37796447300922714</c:v>
                  </c:pt>
                  <c:pt idx="2">
                    <c:v>0.17677669529663689</c:v>
                  </c:pt>
                  <c:pt idx="3">
                    <c:v>0.2672612419124244</c:v>
                  </c:pt>
                  <c:pt idx="4">
                    <c:v>0.20412414523193137</c:v>
                  </c:pt>
                  <c:pt idx="5">
                    <c:v>0.49159604012508745</c:v>
                  </c:pt>
                  <c:pt idx="6">
                    <c:v>0.40824829046386296</c:v>
                  </c:pt>
                  <c:pt idx="7">
                    <c:v>0.26726124191242445</c:v>
                  </c:pt>
                  <c:pt idx="8">
                    <c:v>0.49551560448255744</c:v>
                  </c:pt>
                </c:numCache>
              </c:numRef>
            </c:plus>
            <c:minus>
              <c:numRef>
                <c:f>'14DPI'!$R$29:$Z$29</c:f>
                <c:numCache>
                  <c:formatCode>General</c:formatCode>
                  <c:ptCount val="9"/>
                  <c:pt idx="0">
                    <c:v>0.3779644730092272</c:v>
                  </c:pt>
                  <c:pt idx="1">
                    <c:v>0.37796447300922714</c:v>
                  </c:pt>
                  <c:pt idx="2">
                    <c:v>0.17677669529663689</c:v>
                  </c:pt>
                  <c:pt idx="3">
                    <c:v>0.2672612419124244</c:v>
                  </c:pt>
                  <c:pt idx="4">
                    <c:v>0.20412414523193137</c:v>
                  </c:pt>
                  <c:pt idx="5">
                    <c:v>0.49159604012508745</c:v>
                  </c:pt>
                  <c:pt idx="6">
                    <c:v>0.40824829046386296</c:v>
                  </c:pt>
                  <c:pt idx="7">
                    <c:v>0.26726124191242445</c:v>
                  </c:pt>
                  <c:pt idx="8">
                    <c:v>0.49551560448255744</c:v>
                  </c:pt>
                </c:numCache>
              </c:numRef>
            </c:minus>
          </c:errBars>
          <c:cat>
            <c:strRef>
              <c:f>'14DPI'!$B$9:$J$9</c:f>
              <c:strCache>
                <c:ptCount val="9"/>
                <c:pt idx="0">
                  <c:v>Nz-T4</c:v>
                </c:pt>
                <c:pt idx="1">
                  <c:v>Nz-T4-Ecp11_1</c:v>
                </c:pt>
                <c:pt idx="2">
                  <c:v>Nz-T4-Ecp11_3</c:v>
                </c:pt>
                <c:pt idx="3">
                  <c:v>Nz-T4-Ecp11_4</c:v>
                </c:pt>
                <c:pt idx="4">
                  <c:v>Nz-T4-Ecp11_6</c:v>
                </c:pt>
                <c:pt idx="5">
                  <c:v>Nz-T4-Ecp11_7</c:v>
                </c:pt>
                <c:pt idx="6">
                  <c:v>19.4.24</c:v>
                </c:pt>
                <c:pt idx="7">
                  <c:v>JN3</c:v>
                </c:pt>
                <c:pt idx="8">
                  <c:v>Nz-T4-AvrLm3_1</c:v>
                </c:pt>
              </c:strCache>
            </c:strRef>
          </c:cat>
          <c:val>
            <c:numRef>
              <c:f>'14DPI'!$R$27:$Z$27</c:f>
              <c:numCache>
                <c:formatCode>General</c:formatCode>
                <c:ptCount val="9"/>
                <c:pt idx="0">
                  <c:v>4</c:v>
                </c:pt>
                <c:pt idx="1">
                  <c:v>1.7142857142857142</c:v>
                </c:pt>
                <c:pt idx="2">
                  <c:v>1.875</c:v>
                </c:pt>
                <c:pt idx="3">
                  <c:v>1.5</c:v>
                </c:pt>
                <c:pt idx="4">
                  <c:v>1.8333333333333333</c:v>
                </c:pt>
                <c:pt idx="5">
                  <c:v>1.8333333333333333</c:v>
                </c:pt>
                <c:pt idx="6">
                  <c:v>1.6666666666666667</c:v>
                </c:pt>
                <c:pt idx="7">
                  <c:v>2.4285714285714284</c:v>
                </c:pt>
                <c:pt idx="8">
                  <c:v>1.8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A2E-4122-8B75-C888BC9BDB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9446784"/>
        <c:axId val="99449856"/>
      </c:barChart>
      <c:catAx>
        <c:axId val="994467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99449856"/>
        <c:crosses val="autoZero"/>
        <c:auto val="1"/>
        <c:lblAlgn val="ctr"/>
        <c:lblOffset val="100"/>
        <c:noMultiLvlLbl val="0"/>
      </c:catAx>
      <c:valAx>
        <c:axId val="99449856"/>
        <c:scaling>
          <c:orientation val="minMax"/>
          <c:max val="6"/>
        </c:scaling>
        <c:delete val="0"/>
        <c:axPos val="l"/>
        <c:numFmt formatCode="General" sourceLinked="1"/>
        <c:majorTickMark val="none"/>
        <c:minorTickMark val="none"/>
        <c:tickLblPos val="nextTo"/>
        <c:crossAx val="994467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15.23.4.1 (</a:t>
            </a:r>
            <a:r>
              <a:rPr lang="en-US" i="1" dirty="0"/>
              <a:t>Rlm7</a:t>
            </a:r>
            <a:r>
              <a:rPr lang="en-US" dirty="0"/>
              <a:t>)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14DPI'!$B$9:$J$9</c:f>
              <c:strCache>
                <c:ptCount val="9"/>
                <c:pt idx="0">
                  <c:v>Nz-T4</c:v>
                </c:pt>
                <c:pt idx="1">
                  <c:v>Nz-T4-Ecp11_1</c:v>
                </c:pt>
                <c:pt idx="2">
                  <c:v>Nz-T4-Ecp11_3</c:v>
                </c:pt>
                <c:pt idx="3">
                  <c:v>Nz-T4-Ecp11_4</c:v>
                </c:pt>
                <c:pt idx="4">
                  <c:v>Nz-T4-Ecp11_6</c:v>
                </c:pt>
                <c:pt idx="5">
                  <c:v>Nz-T4-Ecp11_7</c:v>
                </c:pt>
                <c:pt idx="6">
                  <c:v>19.4.24</c:v>
                </c:pt>
                <c:pt idx="7">
                  <c:v>JN3</c:v>
                </c:pt>
                <c:pt idx="8">
                  <c:v>Nz-T4-AvrLm3_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14DPI'!$B$57:$J$57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14DPI'!$B$57:$J$57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</c:errBars>
          <c:cat>
            <c:strRef>
              <c:f>'14DPI'!$B$9:$J$9</c:f>
              <c:strCache>
                <c:ptCount val="9"/>
                <c:pt idx="0">
                  <c:v>Nz-T4</c:v>
                </c:pt>
                <c:pt idx="1">
                  <c:v>Nz-T4-Ecp11_1</c:v>
                </c:pt>
                <c:pt idx="2">
                  <c:v>Nz-T4-Ecp11_3</c:v>
                </c:pt>
                <c:pt idx="3">
                  <c:v>Nz-T4-Ecp11_4</c:v>
                </c:pt>
                <c:pt idx="4">
                  <c:v>Nz-T4-Ecp11_6</c:v>
                </c:pt>
                <c:pt idx="5">
                  <c:v>Nz-T4-Ecp11_7</c:v>
                </c:pt>
                <c:pt idx="6">
                  <c:v>19.4.24</c:v>
                </c:pt>
                <c:pt idx="7">
                  <c:v>JN3</c:v>
                </c:pt>
                <c:pt idx="8">
                  <c:v>Nz-T4-AvrLm3_1</c:v>
                </c:pt>
              </c:strCache>
            </c:strRef>
          </c:cat>
          <c:val>
            <c:numRef>
              <c:f>'14DPI'!$B$55:$J$55</c:f>
              <c:numCache>
                <c:formatCode>General</c:formatCode>
                <c:ptCount val="9"/>
                <c:pt idx="0">
                  <c:v>5</c:v>
                </c:pt>
                <c:pt idx="1">
                  <c:v>5</c:v>
                </c:pt>
                <c:pt idx="2">
                  <c:v>5</c:v>
                </c:pt>
                <c:pt idx="3">
                  <c:v>5</c:v>
                </c:pt>
                <c:pt idx="4">
                  <c:v>5</c:v>
                </c:pt>
                <c:pt idx="5">
                  <c:v>5</c:v>
                </c:pt>
                <c:pt idx="6">
                  <c:v>5</c:v>
                </c:pt>
                <c:pt idx="7">
                  <c:v>1</c:v>
                </c:pt>
                <c:pt idx="8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319-4046-BEB8-AA703485C8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9446784"/>
        <c:axId val="99449856"/>
      </c:barChart>
      <c:catAx>
        <c:axId val="994467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99449856"/>
        <c:crosses val="autoZero"/>
        <c:auto val="1"/>
        <c:lblAlgn val="ctr"/>
        <c:lblOffset val="100"/>
        <c:noMultiLvlLbl val="0"/>
      </c:catAx>
      <c:valAx>
        <c:axId val="99449856"/>
        <c:scaling>
          <c:orientation val="minMax"/>
          <c:max val="6"/>
        </c:scaling>
        <c:delete val="0"/>
        <c:axPos val="l"/>
        <c:numFmt formatCode="General" sourceLinked="1"/>
        <c:majorTickMark val="none"/>
        <c:minorTickMark val="none"/>
        <c:tickLblPos val="nextTo"/>
        <c:crossAx val="994467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 smtClean="0"/>
              <a:t>15.22.4.1 </a:t>
            </a:r>
            <a:r>
              <a:rPr lang="en-US" dirty="0"/>
              <a:t>(</a:t>
            </a:r>
            <a:r>
              <a:rPr lang="en-US" i="1" dirty="0"/>
              <a:t>Rlm3</a:t>
            </a:r>
            <a:r>
              <a:rPr lang="en-US" dirty="0"/>
              <a:t>)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14DPI'!$B$9:$J$9</c:f>
              <c:strCache>
                <c:ptCount val="9"/>
                <c:pt idx="0">
                  <c:v>Nz-T4</c:v>
                </c:pt>
                <c:pt idx="1">
                  <c:v>Nz-T4-Ecp11_1</c:v>
                </c:pt>
                <c:pt idx="2">
                  <c:v>Nz-T4-Ecp11_3</c:v>
                </c:pt>
                <c:pt idx="3">
                  <c:v>Nz-T4-Ecp11_4</c:v>
                </c:pt>
                <c:pt idx="4">
                  <c:v>Nz-T4-Ecp11_6</c:v>
                </c:pt>
                <c:pt idx="5">
                  <c:v>Nz-T4-Ecp11_7</c:v>
                </c:pt>
                <c:pt idx="6">
                  <c:v>19.4.24</c:v>
                </c:pt>
                <c:pt idx="7">
                  <c:v>JN3</c:v>
                </c:pt>
                <c:pt idx="8">
                  <c:v>Nz-T4-AvrLm3_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14DPI'!$R$57:$Z$57</c:f>
                <c:numCache>
                  <c:formatCode>General</c:formatCode>
                  <c:ptCount val="9"/>
                  <c:pt idx="0">
                    <c:v>0.16666666666666669</c:v>
                  </c:pt>
                  <c:pt idx="1">
                    <c:v>0.25819888974716143</c:v>
                  </c:pt>
                  <c:pt idx="2">
                    <c:v>0.48591265790377508</c:v>
                  </c:pt>
                  <c:pt idx="3">
                    <c:v>0.24152294576982364</c:v>
                  </c:pt>
                  <c:pt idx="4">
                    <c:v>0.47193990372426942</c:v>
                  </c:pt>
                  <c:pt idx="5">
                    <c:v>0.41009976613236243</c:v>
                  </c:pt>
                  <c:pt idx="6">
                    <c:v>0.47434164902525694</c:v>
                  </c:pt>
                  <c:pt idx="7">
                    <c:v>0.15075567228888181</c:v>
                  </c:pt>
                  <c:pt idx="8">
                    <c:v>0.25877458475338283</c:v>
                  </c:pt>
                </c:numCache>
              </c:numRef>
            </c:plus>
            <c:minus>
              <c:numRef>
                <c:f>'14DPI'!$R$57:$Z$57</c:f>
                <c:numCache>
                  <c:formatCode>General</c:formatCode>
                  <c:ptCount val="9"/>
                  <c:pt idx="0">
                    <c:v>0.16666666666666669</c:v>
                  </c:pt>
                  <c:pt idx="1">
                    <c:v>0.25819888974716143</c:v>
                  </c:pt>
                  <c:pt idx="2">
                    <c:v>0.48591265790377508</c:v>
                  </c:pt>
                  <c:pt idx="3">
                    <c:v>0.24152294576982364</c:v>
                  </c:pt>
                  <c:pt idx="4">
                    <c:v>0.47193990372426942</c:v>
                  </c:pt>
                  <c:pt idx="5">
                    <c:v>0.41009976613236243</c:v>
                  </c:pt>
                  <c:pt idx="6">
                    <c:v>0.47434164902525694</c:v>
                  </c:pt>
                  <c:pt idx="7">
                    <c:v>0.15075567228888181</c:v>
                  </c:pt>
                  <c:pt idx="8">
                    <c:v>0.25877458475338283</c:v>
                  </c:pt>
                </c:numCache>
              </c:numRef>
            </c:minus>
          </c:errBars>
          <c:cat>
            <c:strRef>
              <c:f>'14DPI'!$B$9:$J$9</c:f>
              <c:strCache>
                <c:ptCount val="9"/>
                <c:pt idx="0">
                  <c:v>Nz-T4</c:v>
                </c:pt>
                <c:pt idx="1">
                  <c:v>Nz-T4-Ecp11_1</c:v>
                </c:pt>
                <c:pt idx="2">
                  <c:v>Nz-T4-Ecp11_3</c:v>
                </c:pt>
                <c:pt idx="3">
                  <c:v>Nz-T4-Ecp11_4</c:v>
                </c:pt>
                <c:pt idx="4">
                  <c:v>Nz-T4-Ecp11_6</c:v>
                </c:pt>
                <c:pt idx="5">
                  <c:v>Nz-T4-Ecp11_7</c:v>
                </c:pt>
                <c:pt idx="6">
                  <c:v>19.4.24</c:v>
                </c:pt>
                <c:pt idx="7">
                  <c:v>JN3</c:v>
                </c:pt>
                <c:pt idx="8">
                  <c:v>Nz-T4-AvrLm3_1</c:v>
                </c:pt>
              </c:strCache>
            </c:strRef>
          </c:cat>
          <c:val>
            <c:numRef>
              <c:f>'14DPI'!$R$55:$Z$55</c:f>
              <c:numCache>
                <c:formatCode>General</c:formatCode>
                <c:ptCount val="9"/>
                <c:pt idx="0">
                  <c:v>4.8888888888888893</c:v>
                </c:pt>
                <c:pt idx="1">
                  <c:v>2.6</c:v>
                </c:pt>
                <c:pt idx="2">
                  <c:v>2.7777777777777777</c:v>
                </c:pt>
                <c:pt idx="3">
                  <c:v>2.7</c:v>
                </c:pt>
                <c:pt idx="4">
                  <c:v>2.0909090909090908</c:v>
                </c:pt>
                <c:pt idx="5">
                  <c:v>2.5454545454545454</c:v>
                </c:pt>
                <c:pt idx="6">
                  <c:v>1.7</c:v>
                </c:pt>
                <c:pt idx="7">
                  <c:v>5.0909090909090908</c:v>
                </c:pt>
                <c:pt idx="8">
                  <c:v>2.6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ED-438F-A41B-88149CC141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9446784"/>
        <c:axId val="99449856"/>
      </c:barChart>
      <c:catAx>
        <c:axId val="994467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99449856"/>
        <c:crosses val="autoZero"/>
        <c:auto val="1"/>
        <c:lblAlgn val="ctr"/>
        <c:lblOffset val="100"/>
        <c:noMultiLvlLbl val="0"/>
      </c:catAx>
      <c:valAx>
        <c:axId val="99449856"/>
        <c:scaling>
          <c:orientation val="minMax"/>
          <c:max val="6"/>
        </c:scaling>
        <c:delete val="0"/>
        <c:axPos val="l"/>
        <c:numFmt formatCode="General" sourceLinked="1"/>
        <c:majorTickMark val="none"/>
        <c:minorTickMark val="none"/>
        <c:tickLblPos val="nextTo"/>
        <c:crossAx val="994467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Pixel (</a:t>
            </a:r>
            <a:r>
              <a:rPr lang="en-US" i="1" dirty="0"/>
              <a:t>Rlm4</a:t>
            </a:r>
            <a:r>
              <a:rPr lang="en-US" dirty="0"/>
              <a:t>)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14DPI'!$B$9:$J$9</c:f>
              <c:strCache>
                <c:ptCount val="9"/>
                <c:pt idx="0">
                  <c:v>Nz-T4</c:v>
                </c:pt>
                <c:pt idx="1">
                  <c:v>Nz-T4-Ecp11_1</c:v>
                </c:pt>
                <c:pt idx="2">
                  <c:v>Nz-T4-Ecp11_3</c:v>
                </c:pt>
                <c:pt idx="3">
                  <c:v>Nz-T4-Ecp11_4</c:v>
                </c:pt>
                <c:pt idx="4">
                  <c:v>Nz-T4-Ecp11_6</c:v>
                </c:pt>
                <c:pt idx="5">
                  <c:v>Nz-T4-Ecp11_7</c:v>
                </c:pt>
                <c:pt idx="6">
                  <c:v>19.4.24</c:v>
                </c:pt>
                <c:pt idx="7">
                  <c:v>JN3</c:v>
                </c:pt>
                <c:pt idx="8">
                  <c:v>Nz-T4-AvrLm3_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14DPI'!$B$92:$J$92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.14433756729740646</c:v>
                  </c:pt>
                  <c:pt idx="6">
                    <c:v>0.15075567228888181</c:v>
                  </c:pt>
                  <c:pt idx="7">
                    <c:v>0.19462473604038083</c:v>
                  </c:pt>
                  <c:pt idx="8">
                    <c:v>0.17677669529663689</c:v>
                  </c:pt>
                </c:numCache>
              </c:numRef>
            </c:plus>
            <c:minus>
              <c:numRef>
                <c:f>'14DPI'!$B$92:$J$92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.14433756729740646</c:v>
                  </c:pt>
                  <c:pt idx="6">
                    <c:v>0.15075567228888181</c:v>
                  </c:pt>
                  <c:pt idx="7">
                    <c:v>0.19462473604038083</c:v>
                  </c:pt>
                  <c:pt idx="8">
                    <c:v>0.17677669529663689</c:v>
                  </c:pt>
                </c:numCache>
              </c:numRef>
            </c:minus>
          </c:errBars>
          <c:cat>
            <c:strRef>
              <c:f>'14DPI'!$B$9:$J$9</c:f>
              <c:strCache>
                <c:ptCount val="9"/>
                <c:pt idx="0">
                  <c:v>Nz-T4</c:v>
                </c:pt>
                <c:pt idx="1">
                  <c:v>Nz-T4-Ecp11_1</c:v>
                </c:pt>
                <c:pt idx="2">
                  <c:v>Nz-T4-Ecp11_3</c:v>
                </c:pt>
                <c:pt idx="3">
                  <c:v>Nz-T4-Ecp11_4</c:v>
                </c:pt>
                <c:pt idx="4">
                  <c:v>Nz-T4-Ecp11_6</c:v>
                </c:pt>
                <c:pt idx="5">
                  <c:v>Nz-T4-Ecp11_7</c:v>
                </c:pt>
                <c:pt idx="6">
                  <c:v>19.4.24</c:v>
                </c:pt>
                <c:pt idx="7">
                  <c:v>JN3</c:v>
                </c:pt>
                <c:pt idx="8">
                  <c:v>Nz-T4-AvrLm3_1</c:v>
                </c:pt>
              </c:strCache>
            </c:strRef>
          </c:cat>
          <c:val>
            <c:numRef>
              <c:f>'14DPI'!$B$90:$J$90</c:f>
              <c:numCache>
                <c:formatCode>General</c:formatCode>
                <c:ptCount val="9"/>
                <c:pt idx="0">
                  <c:v>5</c:v>
                </c:pt>
                <c:pt idx="1">
                  <c:v>5</c:v>
                </c:pt>
                <c:pt idx="2">
                  <c:v>5</c:v>
                </c:pt>
                <c:pt idx="3">
                  <c:v>5</c:v>
                </c:pt>
                <c:pt idx="4">
                  <c:v>5</c:v>
                </c:pt>
                <c:pt idx="5">
                  <c:v>4.916666666666667</c:v>
                </c:pt>
                <c:pt idx="6">
                  <c:v>5.0909090909090908</c:v>
                </c:pt>
                <c:pt idx="7">
                  <c:v>1.1666666666666667</c:v>
                </c:pt>
                <c:pt idx="8">
                  <c:v>5.1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CFE-475C-B2D5-C52337360F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9446784"/>
        <c:axId val="99449856"/>
      </c:barChart>
      <c:catAx>
        <c:axId val="994467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99449856"/>
        <c:crosses val="autoZero"/>
        <c:auto val="1"/>
        <c:lblAlgn val="ctr"/>
        <c:lblOffset val="100"/>
        <c:noMultiLvlLbl val="0"/>
      </c:catAx>
      <c:valAx>
        <c:axId val="99449856"/>
        <c:scaling>
          <c:orientation val="minMax"/>
          <c:max val="6"/>
        </c:scaling>
        <c:delete val="0"/>
        <c:axPos val="l"/>
        <c:numFmt formatCode="General" sourceLinked="1"/>
        <c:majorTickMark val="none"/>
        <c:minorTickMark val="none"/>
        <c:tickLblPos val="nextTo"/>
        <c:crossAx val="994467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50565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1316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33862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1385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87162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8585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5553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4725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96404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29532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2427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056AA5-2E63-45BD-BB54-48B417DE9D91}" type="datetimeFigureOut">
              <a:rPr lang="fr-FR" smtClean="0"/>
              <a:t>21/06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FA83F3-8248-41D3-ABBF-8CC538084F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6345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Graphique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5380668"/>
              </p:ext>
            </p:extLst>
          </p:nvPr>
        </p:nvGraphicFramePr>
        <p:xfrm>
          <a:off x="1507079" y="549468"/>
          <a:ext cx="4632325" cy="3184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Graphique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1449840"/>
              </p:ext>
            </p:extLst>
          </p:nvPr>
        </p:nvGraphicFramePr>
        <p:xfrm>
          <a:off x="6393404" y="568518"/>
          <a:ext cx="4632325" cy="3184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Graphique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064787"/>
              </p:ext>
            </p:extLst>
          </p:nvPr>
        </p:nvGraphicFramePr>
        <p:xfrm>
          <a:off x="1478504" y="4067368"/>
          <a:ext cx="4632325" cy="3184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Graphique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4359871"/>
              </p:ext>
            </p:extLst>
          </p:nvPr>
        </p:nvGraphicFramePr>
        <p:xfrm>
          <a:off x="6209254" y="4067368"/>
          <a:ext cx="4632325" cy="3184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" name="Graphique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9808105"/>
              </p:ext>
            </p:extLst>
          </p:nvPr>
        </p:nvGraphicFramePr>
        <p:xfrm>
          <a:off x="1507078" y="7619708"/>
          <a:ext cx="4632325" cy="3184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4" name="Rectangle 13"/>
          <p:cNvSpPr/>
          <p:nvPr/>
        </p:nvSpPr>
        <p:spPr>
          <a:xfrm>
            <a:off x="1578543" y="11891874"/>
            <a:ext cx="9021386" cy="27980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300"/>
              </a:spcAft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5. 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cp11-1 of </a:t>
            </a:r>
            <a:r>
              <a:rPr lang="en-US" b="1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. </a:t>
            </a:r>
            <a:r>
              <a:rPr lang="en-US" b="1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lva</a:t>
            </a:r>
            <a:r>
              <a:rPr lang="en-US" b="1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iggers Rlm3-mediated recognition in </a:t>
            </a:r>
            <a:r>
              <a:rPr lang="en-US" b="1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b="1" i="1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culans</a:t>
            </a:r>
            <a:endParaRPr lang="fr-FR" sz="2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30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ld type isolates Nz-T4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1a3a4a7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N3 (A1a3A4A7) and 19.4.24 (A1A3a4a7),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 well as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z-T4 </a:t>
            </a:r>
            <a:r>
              <a:rPr lang="en-US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ansformants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arrying </a:t>
            </a:r>
            <a:r>
              <a:rPr lang="en-US" i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CP11-1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US" i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vrLm3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oculated onto cotyledons of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ree cultivars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rrying </a:t>
            </a: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lm3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5.22.4.1, Grizzly and Columbus), </a:t>
            </a:r>
            <a:r>
              <a:rPr lang="en-US" i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lm7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15.23.4.1) or </a:t>
            </a: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lm4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ixel)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.23.4.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sister line of 15.22.4.1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sue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individual plants from cv.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ngi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arrying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lm7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tead of 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lm3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Pathogenicity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as measured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5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ys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st-inoculation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sults are expressed as a mean scoring using the IMASCORE rating comprising six infection classes (IC), where IC1 to IC3 correspond to resistance, and IC4 to IC6 to </a:t>
            </a:r>
            <a:r>
              <a:rPr lang="en-US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sceptibility </a:t>
            </a:r>
            <a:r>
              <a:rPr lang="en-US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[50]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rror bars indicate the standard deviation of technical replicates. </a:t>
            </a:r>
            <a:endParaRPr lang="fr-FR" sz="2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55303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296</TotalTime>
  <Words>161</Words>
  <Application>Microsoft Office PowerPoint</Application>
  <PresentationFormat>Personnalisé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sabelle Fudal</dc:creator>
  <cp:lastModifiedBy>Isabelle Fudal</cp:lastModifiedBy>
  <cp:revision>18</cp:revision>
  <dcterms:created xsi:type="dcterms:W3CDTF">2021-07-14T15:02:05Z</dcterms:created>
  <dcterms:modified xsi:type="dcterms:W3CDTF">2022-06-21T15:01:29Z</dcterms:modified>
</cp:coreProperties>
</file>